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4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C8131-B2A2-4E29-B33A-455694564F1A}" type="datetimeFigureOut">
              <a:rPr lang="es-ES" smtClean="0"/>
              <a:t>18/1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D5D2-C921-453F-BDDA-B82C3BD15F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5604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C8131-B2A2-4E29-B33A-455694564F1A}" type="datetimeFigureOut">
              <a:rPr lang="es-ES" smtClean="0"/>
              <a:t>18/1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D5D2-C921-453F-BDDA-B82C3BD15F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6490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C8131-B2A2-4E29-B33A-455694564F1A}" type="datetimeFigureOut">
              <a:rPr lang="es-ES" smtClean="0"/>
              <a:t>18/1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D5D2-C921-453F-BDDA-B82C3BD15F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1529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C8131-B2A2-4E29-B33A-455694564F1A}" type="datetimeFigureOut">
              <a:rPr lang="es-ES" smtClean="0"/>
              <a:t>18/1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D5D2-C921-453F-BDDA-B82C3BD15F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8762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C8131-B2A2-4E29-B33A-455694564F1A}" type="datetimeFigureOut">
              <a:rPr lang="es-ES" smtClean="0"/>
              <a:t>18/1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D5D2-C921-453F-BDDA-B82C3BD15F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3339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C8131-B2A2-4E29-B33A-455694564F1A}" type="datetimeFigureOut">
              <a:rPr lang="es-ES" smtClean="0"/>
              <a:t>18/11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D5D2-C921-453F-BDDA-B82C3BD15F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3092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C8131-B2A2-4E29-B33A-455694564F1A}" type="datetimeFigureOut">
              <a:rPr lang="es-ES" smtClean="0"/>
              <a:t>18/11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D5D2-C921-453F-BDDA-B82C3BD15F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2511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C8131-B2A2-4E29-B33A-455694564F1A}" type="datetimeFigureOut">
              <a:rPr lang="es-ES" smtClean="0"/>
              <a:t>18/11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D5D2-C921-453F-BDDA-B82C3BD15F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2716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C8131-B2A2-4E29-B33A-455694564F1A}" type="datetimeFigureOut">
              <a:rPr lang="es-ES" smtClean="0"/>
              <a:t>18/11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D5D2-C921-453F-BDDA-B82C3BD15F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4631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C8131-B2A2-4E29-B33A-455694564F1A}" type="datetimeFigureOut">
              <a:rPr lang="es-ES" smtClean="0"/>
              <a:t>18/11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D5D2-C921-453F-BDDA-B82C3BD15F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1538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C8131-B2A2-4E29-B33A-455694564F1A}" type="datetimeFigureOut">
              <a:rPr lang="es-ES" smtClean="0"/>
              <a:t>18/11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D5D2-C921-453F-BDDA-B82C3BD15F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4885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C8131-B2A2-4E29-B33A-455694564F1A}" type="datetimeFigureOut">
              <a:rPr lang="es-ES" smtClean="0"/>
              <a:t>18/1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C5D5D2-C921-453F-BDDA-B82C3BD15F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9730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260649" y="776537"/>
          <a:ext cx="6408710" cy="7996825"/>
        </p:xfrm>
        <a:graphic>
          <a:graphicData uri="http://schemas.openxmlformats.org/drawingml/2006/table">
            <a:tbl>
              <a:tblPr/>
              <a:tblGrid>
                <a:gridCol w="7505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4828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4828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3072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5959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3642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13482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3510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FFFFFF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Couso embryo expression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96B2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FFFFFF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Berkeley embryo expression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96B2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510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FFFFFF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smORF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A7C2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St1-6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St9-13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St 14-17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St1-6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St9-13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St 14-17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4499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6770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Maternal; ubiquitous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Amnioserosa; faint epidermis; proventriculu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Gut/malphigian tubes/salivary gland/ weak epidermi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Maternal; Ubiquitous; pole cell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Germ cells; amnioserosa; crystal cell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latin typeface="Aptos"/>
                          <a:ea typeface="Times New Roman"/>
                          <a:cs typeface="Times New Roman"/>
                        </a:rPr>
                        <a:t>Crystal cells, amnioserosa, epidemis; anal pads; proventriculu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4499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8860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Maternal; Ubiquitou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Mesoderm; midgut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Visceral mesoderm; somatic mesoderm; midgut; proventriculu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2999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CG9034/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i="1" dirty="0" err="1">
                          <a:latin typeface="Aptos"/>
                          <a:ea typeface="Times New Roman"/>
                          <a:cs typeface="Times New Roman"/>
                        </a:rPr>
                        <a:t>prto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Maternal;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ephalic furrow, mesoderm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Mesoderm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Visceral mesoderm;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somatic mesoderm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645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CG11686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No expression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No expression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Salivary gland duct; trachea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3749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12384/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latin typeface="Aptos"/>
                          <a:ea typeface="Times New Roman"/>
                          <a:cs typeface="Times New Roman"/>
                        </a:rPr>
                        <a:t>dap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Maternal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No staining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Foregut hindgut; 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proventriculus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; 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pharinx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latin typeface="Aptos"/>
                          <a:ea typeface="Times New Roman"/>
                          <a:cs typeface="Times New Roman"/>
                        </a:rPr>
                        <a:t>; faint epidermis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75248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12643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Faint ubiquitou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Fore and hindgut; faint endoderm 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latin typeface="Aptos"/>
                          <a:ea typeface="Times New Roman"/>
                          <a:cs typeface="Times New Roman"/>
                        </a:rPr>
                        <a:t>Epidermis dorsal closure; imaginal disc primordia, epidermal stripe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695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14104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Maternal;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Faint gut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midgut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2012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CG17278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o expression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Mesoderm and head organs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Tracheal pits; mesoderm; head organs; PNS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o expression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Head segments 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Head segments; tracheal pits; mesoderm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499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17343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ectoderm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Epidermis, CN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NS, epidermi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499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17931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Maternal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Ubiquitou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Ubiquitou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499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18081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Maternal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Ubiquitou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Ubiquitou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58017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CG32276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Maternal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Trachea; endoderm-gut; mesoderm; salivary gland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Trachea; muscle; proventriculus; salivary gland; 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Maternal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Endoderm; mesoderm; trachea; salivary gland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Salivary gland; epidermi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0010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33170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Maternal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gut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gut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1499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33199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No staining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No staining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 gut, CN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Maternal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Endoderm; gut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Gut, CNS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1764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34200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No staining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No staining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Faint midgut 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Maternal 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No staining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Midgut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1499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34242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 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Maternal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Faint ubiquitous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Midgut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7645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34250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Maternal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o expression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Differentiated trachea?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32249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CG42371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latin typeface="Aptos"/>
                          <a:ea typeface="Times New Roman"/>
                          <a:cs typeface="Times New Roman"/>
                        </a:rPr>
                        <a:t>Maternal;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latin typeface="Aptos"/>
                          <a:ea typeface="Times New Roman"/>
                          <a:cs typeface="Times New Roman"/>
                        </a:rPr>
                        <a:t>faint ubiquitous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Faint ubiquitou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Gut; hemocytes epidermi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Maternal; Ubiquitous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Midgut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>
                          <a:latin typeface="Aptos"/>
                          <a:ea typeface="Times New Roman"/>
                          <a:cs typeface="Times New Roman"/>
                        </a:rPr>
                        <a:t>Midgut</a:t>
                      </a: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  and hindgut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1499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latin typeface="Aptos"/>
                          <a:ea typeface="Times New Roman"/>
                          <a:cs typeface="Times New Roman"/>
                        </a:rPr>
                        <a:t>CG43194</a:t>
                      </a: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o expression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Hemocytes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Hemocytes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64499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CG44242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o expression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latin typeface="Aptos"/>
                          <a:ea typeface="Times New Roman"/>
                          <a:cs typeface="Times New Roman"/>
                        </a:rPr>
                        <a:t>Mesoderm</a:t>
                      </a:r>
                      <a:endParaRPr lang="en-GB" sz="90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Visceral Mesoderm; somatic mesoderm; </a:t>
                      </a:r>
                      <a:r>
                        <a:rPr lang="en-US" sz="900" dirty="0" err="1">
                          <a:latin typeface="Aptos"/>
                          <a:ea typeface="Times New Roman"/>
                          <a:cs typeface="Times New Roman"/>
                        </a:rPr>
                        <a:t>Malpighian</a:t>
                      </a: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 tubes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ptos"/>
                          <a:ea typeface="Times New Roman"/>
                          <a:cs typeface="Times New Roman"/>
                        </a:rPr>
                        <a:t>NA</a:t>
                      </a:r>
                      <a:endParaRPr lang="en-GB" sz="900" dirty="0">
                        <a:latin typeface="Aptos"/>
                        <a:ea typeface="Aptos"/>
                        <a:cs typeface="Times New Roman"/>
                      </a:endParaRPr>
                    </a:p>
                  </a:txBody>
                  <a:tcPr marL="19858" marR="198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80729" y="9129465"/>
            <a:ext cx="5328592" cy="5387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dirty="0" err="1"/>
              <a:t>Sup</a:t>
            </a:r>
            <a:r>
              <a:rPr lang="es-ES_tradnl" dirty="0"/>
              <a:t> </a:t>
            </a:r>
            <a:r>
              <a:rPr lang="es-ES_tradnl"/>
              <a:t>File S3</a:t>
            </a:r>
            <a:r>
              <a:rPr lang="es-ES_tradnl" dirty="0"/>
              <a:t>. </a:t>
            </a:r>
            <a:r>
              <a:rPr lang="es-ES_tradnl" dirty="0" err="1"/>
              <a:t>Embryonic</a:t>
            </a:r>
            <a:r>
              <a:rPr lang="es-ES_tradnl" dirty="0"/>
              <a:t> </a:t>
            </a:r>
            <a:r>
              <a:rPr lang="es-ES_tradnl" dirty="0" err="1"/>
              <a:t>patterns</a:t>
            </a:r>
            <a:r>
              <a:rPr lang="es-ES_tradnl" dirty="0"/>
              <a:t> of </a:t>
            </a:r>
            <a:r>
              <a:rPr lang="es-ES_tradnl" dirty="0" err="1"/>
              <a:t>sCDS</a:t>
            </a:r>
            <a:r>
              <a:rPr lang="es-ES_tradnl" dirty="0"/>
              <a:t> </a:t>
            </a:r>
            <a:r>
              <a:rPr lang="es-ES_tradnl" dirty="0" err="1"/>
              <a:t>expression</a:t>
            </a:r>
            <a:r>
              <a:rPr lang="es-ES_tradnl" dirty="0"/>
              <a:t>, </a:t>
            </a:r>
          </a:p>
          <a:p>
            <a:r>
              <a:rPr lang="es-ES_tradnl" sz="1101" dirty="0"/>
              <a:t>as </a:t>
            </a:r>
            <a:r>
              <a:rPr lang="es-ES_tradnl" sz="1101" dirty="0" err="1"/>
              <a:t>detected</a:t>
            </a:r>
            <a:r>
              <a:rPr lang="es-ES_tradnl" sz="1101" dirty="0"/>
              <a:t> </a:t>
            </a:r>
            <a:r>
              <a:rPr lang="es-ES_tradnl" sz="1101" dirty="0" err="1"/>
              <a:t>by</a:t>
            </a:r>
            <a:r>
              <a:rPr lang="es-ES_tradnl" sz="1101" dirty="0"/>
              <a:t> </a:t>
            </a:r>
            <a:r>
              <a:rPr lang="es-ES_tradnl" sz="1101" dirty="0" err="1"/>
              <a:t>us</a:t>
            </a:r>
            <a:r>
              <a:rPr lang="es-ES_tradnl" sz="1101" dirty="0"/>
              <a:t> </a:t>
            </a:r>
            <a:r>
              <a:rPr lang="es-ES_tradnl" sz="1101" dirty="0" err="1"/>
              <a:t>or</a:t>
            </a:r>
            <a:r>
              <a:rPr lang="es-ES_tradnl" sz="1101" dirty="0"/>
              <a:t> </a:t>
            </a:r>
            <a:r>
              <a:rPr lang="es-ES_tradnl" sz="1101" dirty="0" err="1"/>
              <a:t>obtained</a:t>
            </a:r>
            <a:r>
              <a:rPr lang="es-ES_tradnl" sz="1101" dirty="0"/>
              <a:t> </a:t>
            </a:r>
            <a:r>
              <a:rPr lang="es-ES_tradnl" sz="1101" dirty="0" err="1"/>
              <a:t>from</a:t>
            </a:r>
            <a:r>
              <a:rPr lang="es-ES_tradnl" sz="1101" dirty="0"/>
              <a:t> </a:t>
            </a:r>
            <a:r>
              <a:rPr lang="es-ES_tradnl" sz="1101" dirty="0" err="1"/>
              <a:t>the</a:t>
            </a:r>
            <a:r>
              <a:rPr lang="es-ES_tradnl" sz="1101" dirty="0"/>
              <a:t> Berkeley </a:t>
            </a:r>
            <a:r>
              <a:rPr lang="es-ES_tradnl" sz="1101" dirty="0" err="1"/>
              <a:t>Drosophila</a:t>
            </a:r>
            <a:r>
              <a:rPr lang="es-ES_tradnl" sz="1101" dirty="0"/>
              <a:t> </a:t>
            </a:r>
            <a:r>
              <a:rPr lang="es-ES_tradnl" sz="1101" dirty="0" err="1"/>
              <a:t>Genome</a:t>
            </a:r>
            <a:r>
              <a:rPr lang="es-ES_tradnl" sz="1101" dirty="0"/>
              <a:t> Project</a:t>
            </a:r>
            <a:endParaRPr lang="en-GB" sz="110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357</Words>
  <Application>Microsoft Office PowerPoint</Application>
  <PresentationFormat>A4 (210 x 297 mm)</PresentationFormat>
  <Paragraphs>15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</dc:creator>
  <cp:lastModifiedBy>ANA</cp:lastModifiedBy>
  <cp:revision>2</cp:revision>
  <dcterms:created xsi:type="dcterms:W3CDTF">2024-11-18T15:40:40Z</dcterms:created>
  <dcterms:modified xsi:type="dcterms:W3CDTF">2024-11-18T16:09:19Z</dcterms:modified>
</cp:coreProperties>
</file>